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1086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4922E-968E-4F2F-99E9-44B7434AAB23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A339D-B5F3-4631-8952-BBCA2DCC1D5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4922E-968E-4F2F-99E9-44B7434AAB23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A339D-B5F3-4631-8952-BBCA2DCC1D5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4922E-968E-4F2F-99E9-44B7434AAB23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A339D-B5F3-4631-8952-BBCA2DCC1D5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4922E-968E-4F2F-99E9-44B7434AAB23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A339D-B5F3-4631-8952-BBCA2DCC1D5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4922E-968E-4F2F-99E9-44B7434AAB23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A339D-B5F3-4631-8952-BBCA2DCC1D5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4922E-968E-4F2F-99E9-44B7434AAB23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A339D-B5F3-4631-8952-BBCA2DCC1D5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4922E-968E-4F2F-99E9-44B7434AAB23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A339D-B5F3-4631-8952-BBCA2DCC1D5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4922E-968E-4F2F-99E9-44B7434AAB23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A339D-B5F3-4631-8952-BBCA2DCC1D5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4922E-968E-4F2F-99E9-44B7434AAB23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A339D-B5F3-4631-8952-BBCA2DCC1D5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4922E-968E-4F2F-99E9-44B7434AAB23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A339D-B5F3-4631-8952-BBCA2DCC1D5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4922E-968E-4F2F-99E9-44B7434AAB23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A339D-B5F3-4631-8952-BBCA2DCC1D5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34922E-968E-4F2F-99E9-44B7434AAB23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2A339D-B5F3-4631-8952-BBCA2DCC1D50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philip.roberts@ucr.edu" TargetMode="External"/><Relationship Id="rId2" Type="http://schemas.openxmlformats.org/officeDocument/2006/relationships/hyperlink" Target="mailto:timothy.close@ucr.edu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914400" y="1600200"/>
            <a:ext cx="7166449" cy="19389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enetic Mapping, Synteny and Physical Location of Two Loci for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usarium oxysporum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f.sp.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racheiphilum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Race 4 Resistance in Cowpea [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Vign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unguiculat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(L.) </a:t>
            </a: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Walp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]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olecular Breeding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Authors and Affiliations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arti O. Pottorff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uojing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Li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2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Jeffery D. Ehlers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3,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Timothy J. Close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d Philip A. Roberts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4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partment of Botany &amp; Plant Sciences, University of California Riverside, Riverside, CA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2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Zhejiang Academy of Agricultural Sciences, Hangzhou, P.R. China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3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Bill &amp; Melinda Gates Foundation, Seattle, Washington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4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partment of Nematology, University of California Riverside, Riverside, CA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orresponding author: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  <a:hlinkClick r:id="rId2"/>
              </a:rPr>
              <a:t>timothy.close@ucr.edu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nd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  <a:hlinkClick r:id="rId3"/>
              </a:rPr>
              <a:t>philip.roberts@ucr.edu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:\Documents and Settings\Marti\Desktop\Freq Distribution graphs 10-7-2013\Slide1.TIF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89202" y="522514"/>
            <a:ext cx="7765596" cy="58129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2</Words>
  <Application>Microsoft Office PowerPoint</Application>
  <PresentationFormat>On-screen Show (4:3)</PresentationFormat>
  <Paragraphs>1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rti</dc:creator>
  <cp:lastModifiedBy>Marti</cp:lastModifiedBy>
  <cp:revision>1</cp:revision>
  <dcterms:created xsi:type="dcterms:W3CDTF">2013-11-13T12:17:44Z</dcterms:created>
  <dcterms:modified xsi:type="dcterms:W3CDTF">2013-11-13T12:18:33Z</dcterms:modified>
</cp:coreProperties>
</file>